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60" r:id="rId4"/>
    <p:sldId id="258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20"/>
  </p:normalViewPr>
  <p:slideViewPr>
    <p:cSldViewPr snapToGrid="0">
      <p:cViewPr varScale="1">
        <p:scale>
          <a:sx n="105" d="100"/>
          <a:sy n="105" d="100"/>
        </p:scale>
        <p:origin x="84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B88571-96CE-9639-179B-44FA038053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FDABAD-E683-4B5F-E337-A9AE6E49BA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7FEF76-3AB4-4733-DC9D-C865DCB56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3AFC-81D8-9149-9876-9A77B4801713}" type="datetimeFigureOut">
              <a:rPr lang="en-US" smtClean="0"/>
              <a:t>8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905DAB-9B9D-0C83-7EF6-9E9296C6A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B9F435-2341-4550-1DFE-A0D41BF917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E2547-8A28-5942-988F-8D5695A75B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788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4362D1-B639-8C9A-0235-5196570C91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35CD94-64BE-EF50-0A32-264CF44F54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EB32C7-C3B3-89B2-6469-B67AC6AB22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3AFC-81D8-9149-9876-9A77B4801713}" type="datetimeFigureOut">
              <a:rPr lang="en-US" smtClean="0"/>
              <a:t>8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E7F53B-B829-B819-AC73-F8ACB782D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24EF47-1197-EC07-2C34-C80225C5A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E2547-8A28-5942-988F-8D5695A75B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044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1D83999-EF21-D440-4F04-BF56DDC592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04E21A-486C-011F-D9B3-17B183C905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5C38C1-9E9D-B71A-E31E-84210F8680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3AFC-81D8-9149-9876-9A77B4801713}" type="datetimeFigureOut">
              <a:rPr lang="en-US" smtClean="0"/>
              <a:t>8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DF088A-92A3-3F26-9195-4B10F66AA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00F0CA-4E96-3F45-4116-341942560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E2547-8A28-5942-988F-8D5695A75B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920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4100B1-DC86-9A8A-8142-18CDA9B51A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05ECB2-DF22-F108-2F98-D7C1BDAF1E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DE3A88-5901-FF8E-7580-8B8C17F04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3AFC-81D8-9149-9876-9A77B4801713}" type="datetimeFigureOut">
              <a:rPr lang="en-US" smtClean="0"/>
              <a:t>8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04478D-10C8-D568-AF94-6138DDEE37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91EDD3-03A4-E4C3-623B-2A3CC77D7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E2547-8A28-5942-988F-8D5695A75B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464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651924-C80D-4494-A927-25E5EEF944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E611DA-68FA-FF92-FFD2-82D0AB40F9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5CE12F-090A-33A8-F751-25B87AC27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3AFC-81D8-9149-9876-9A77B4801713}" type="datetimeFigureOut">
              <a:rPr lang="en-US" smtClean="0"/>
              <a:t>8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6290EA-EC2A-BFFD-7E7B-3BDF87AE7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51414A-6223-1859-B402-C65C3841E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E2547-8A28-5942-988F-8D5695A75B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08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DEBA05-55FD-4817-4FEE-0A908305E7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EC75D0-4823-6CE1-F7BA-9B6283483CE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21207A-568F-8163-5987-07D7A2B420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78767F-8CD6-9EEA-7792-DA2A097878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3AFC-81D8-9149-9876-9A77B4801713}" type="datetimeFigureOut">
              <a:rPr lang="en-US" smtClean="0"/>
              <a:t>8/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33B424-D70E-689B-CF71-765C777B70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5BC950-A60B-3BBC-5609-E86C65FFD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E2547-8A28-5942-988F-8D5695A75B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132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D0B70-1C59-0F19-ACBB-444C2775D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B39EEB-5DB6-5ED5-46D8-B55528546E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61FBAD-F752-0F7B-B08D-61C9A95664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3E91B56-7C11-D639-3DE3-AFAA6A9B56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4BB116-3C8B-5534-A1EA-0FCD0E59C9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42560A5-8B35-0FDD-B5EA-45616153E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3AFC-81D8-9149-9876-9A77B4801713}" type="datetimeFigureOut">
              <a:rPr lang="en-US" smtClean="0"/>
              <a:t>8/9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8514133-A040-FA52-C5FA-66197E8EA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4DCB57E-D80E-878A-73C3-6D1E6BBB0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E2547-8A28-5942-988F-8D5695A75B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969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DD901D-CDEE-36C7-E2F3-306691DB56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AA7C355-51D0-B3B4-A133-B27B4596F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3AFC-81D8-9149-9876-9A77B4801713}" type="datetimeFigureOut">
              <a:rPr lang="en-US" smtClean="0"/>
              <a:t>8/9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8E18F02-9473-D6BD-1127-4D0EA8ABC1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966433-EF39-9114-9C8F-CD2C29E0E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E2547-8A28-5942-988F-8D5695A75B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794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D88DA49-A765-BE44-EE02-CDA4680AC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3AFC-81D8-9149-9876-9A77B4801713}" type="datetimeFigureOut">
              <a:rPr lang="en-US" smtClean="0"/>
              <a:t>8/9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2E9C2C1-307A-0A60-478B-24CD930F64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8A7BD05-0DB6-4588-742B-B543C0E8F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E2547-8A28-5942-988F-8D5695A75B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378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BA2FC5-C031-980D-FC93-6B9CE5EC14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9F97B2-AE3E-88AB-4BEE-C4114142B9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6C9C0D-06F7-919D-316B-272C39D6F1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275CD0-C405-9BCA-B90A-217320875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3AFC-81D8-9149-9876-9A77B4801713}" type="datetimeFigureOut">
              <a:rPr lang="en-US" smtClean="0"/>
              <a:t>8/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7832E0-BF1F-2C23-0976-20549A29D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EE97FD-B061-837B-28CD-2B5672F78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E2547-8A28-5942-988F-8D5695A75B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859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890637-188F-2107-C7AF-D69A8E98D4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61FA8B8-F0CB-DB95-54B9-4150C910F8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B036F8-173C-6E01-AF88-B8A1723325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E5F583-F439-2F05-8EE8-C26C472063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3AFC-81D8-9149-9876-9A77B4801713}" type="datetimeFigureOut">
              <a:rPr lang="en-US" smtClean="0"/>
              <a:t>8/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64C75B-24FA-A187-C5F9-F6EC6358B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965CA2-6582-2A91-D010-93FEBACA2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E2547-8A28-5942-988F-8D5695A75B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571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2C99B8C-7160-4A8F-3B7C-7114CDD9BF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FEB1A7-EAE5-4ADC-897E-CC9E261655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E03C47-22BF-2585-5D9A-0CC189263C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163AFC-81D8-9149-9876-9A77B4801713}" type="datetimeFigureOut">
              <a:rPr lang="en-US" smtClean="0"/>
              <a:t>8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E2BD54-C6D7-1448-D010-62FD1FF9CE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D101C5-3B0E-0C83-E7E0-443135A0E7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E2547-8A28-5942-988F-8D5695A75B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723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C4EC221-7AAD-2BCD-6D7D-F7F70F5209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1992" y="438912"/>
            <a:ext cx="7772400" cy="202039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9FCC11D-4B3F-29BF-5565-C03BBC772D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19020" y="3047662"/>
            <a:ext cx="7772400" cy="199049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73AD0EA-1F03-C08E-0436-6DB5E18C73AA}"/>
              </a:ext>
            </a:extLst>
          </p:cNvPr>
          <p:cNvSpPr txBox="1"/>
          <p:nvPr/>
        </p:nvSpPr>
        <p:spPr>
          <a:xfrm>
            <a:off x="353568" y="438912"/>
            <a:ext cx="10887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 3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B9FA53B-D45F-717D-6AE0-5ED29A4B3F2B}"/>
              </a:ext>
            </a:extLst>
          </p:cNvPr>
          <p:cNvSpPr txBox="1"/>
          <p:nvPr/>
        </p:nvSpPr>
        <p:spPr>
          <a:xfrm>
            <a:off x="10326624" y="1449108"/>
            <a:ext cx="1706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leaved PAR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DFD15BC-02CB-588E-31B9-520813DA3732}"/>
              </a:ext>
            </a:extLst>
          </p:cNvPr>
          <p:cNvSpPr txBox="1"/>
          <p:nvPr/>
        </p:nvSpPr>
        <p:spPr>
          <a:xfrm>
            <a:off x="10632476" y="3858242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83A3E7D-0BDC-10B0-7368-3342A8F167CF}"/>
              </a:ext>
            </a:extLst>
          </p:cNvPr>
          <p:cNvSpPr txBox="1"/>
          <p:nvPr/>
        </p:nvSpPr>
        <p:spPr>
          <a:xfrm>
            <a:off x="366616" y="4576489"/>
            <a:ext cx="1868845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rastuzumab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-DM1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HES0488A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HES0815A</a:t>
            </a: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9DFD5F2-5747-1620-C9B6-524F706084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53100" y="3327400"/>
            <a:ext cx="685800" cy="203200"/>
          </a:xfrm>
          <a:prstGeom prst="rect">
            <a:avLst/>
          </a:prstGeom>
        </p:spPr>
      </p:pic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2D5047FD-AC86-F1FC-4905-E7E982A35F58}"/>
              </a:ext>
            </a:extLst>
          </p:cNvPr>
          <p:cNvCxnSpPr>
            <a:cxnSpLocks/>
          </p:cNvCxnSpPr>
          <p:nvPr/>
        </p:nvCxnSpPr>
        <p:spPr>
          <a:xfrm flipH="1">
            <a:off x="8851392" y="1633728"/>
            <a:ext cx="1475232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46FD8CC9-ABC4-4B20-0D83-39AE63E979E5}"/>
              </a:ext>
            </a:extLst>
          </p:cNvPr>
          <p:cNvCxnSpPr>
            <a:cxnSpLocks/>
          </p:cNvCxnSpPr>
          <p:nvPr/>
        </p:nvCxnSpPr>
        <p:spPr>
          <a:xfrm flipH="1">
            <a:off x="9674352" y="4042908"/>
            <a:ext cx="946149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677704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E4D58A4-CDF9-652F-08FA-DDDEBFF728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3344" y="507572"/>
            <a:ext cx="4673600" cy="19177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00168A9-7B38-4DB8-B59F-1614F73E2B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5536" y="4501388"/>
            <a:ext cx="3149600" cy="2463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DDA0994-2D6D-8DD1-F8CB-902A0A515B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20619" y="864378"/>
            <a:ext cx="4064000" cy="11049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A7780F5-87F8-6175-F486-1AA3B2118CB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95259" y="2470166"/>
            <a:ext cx="4533900" cy="19431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A57CCCFD-DCE7-6D8A-96F7-B920B5D62D2E}"/>
              </a:ext>
            </a:extLst>
          </p:cNvPr>
          <p:cNvSpPr txBox="1"/>
          <p:nvPr/>
        </p:nvSpPr>
        <p:spPr>
          <a:xfrm>
            <a:off x="112687" y="0"/>
            <a:ext cx="1072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 3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91F6256-0345-F8B8-4524-FB16D204BF83}"/>
              </a:ext>
            </a:extLst>
          </p:cNvPr>
          <p:cNvSpPr txBox="1"/>
          <p:nvPr/>
        </p:nvSpPr>
        <p:spPr>
          <a:xfrm>
            <a:off x="5322065" y="872996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H2AX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9554560-55C4-0EDD-5D17-D7D5EBC2144B}"/>
              </a:ext>
            </a:extLst>
          </p:cNvPr>
          <p:cNvSpPr txBox="1"/>
          <p:nvPr/>
        </p:nvSpPr>
        <p:spPr>
          <a:xfrm>
            <a:off x="5322065" y="5420603"/>
            <a:ext cx="1120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tal p5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7231902-E623-9562-FECB-EC735AD99520}"/>
              </a:ext>
            </a:extLst>
          </p:cNvPr>
          <p:cNvSpPr txBox="1"/>
          <p:nvPr/>
        </p:nvSpPr>
        <p:spPr>
          <a:xfrm>
            <a:off x="10675408" y="1462306"/>
            <a:ext cx="1787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CHK2(Thr68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44F30AB-0B54-197C-DBBD-7FA07156452C}"/>
              </a:ext>
            </a:extLst>
          </p:cNvPr>
          <p:cNvSpPr txBox="1"/>
          <p:nvPr/>
        </p:nvSpPr>
        <p:spPr>
          <a:xfrm>
            <a:off x="11044748" y="301420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AF4D9DB-5E3B-AF84-89C6-2AC2EE5B9C60}"/>
              </a:ext>
            </a:extLst>
          </p:cNvPr>
          <p:cNvSpPr txBox="1"/>
          <p:nvPr/>
        </p:nvSpPr>
        <p:spPr>
          <a:xfrm>
            <a:off x="7120128" y="4925568"/>
            <a:ext cx="3057312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ree drug (1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HES0815A (20 ng/ml)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HES0815A (100 ng/ml)</a:t>
            </a:r>
          </a:p>
          <a:p>
            <a:pPr marL="342900" indent="-342900">
              <a:buFont typeface="+mj-lt"/>
              <a:buAutoNum type="arabicPeriod"/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41633EF-0357-B4CC-5CBA-8D1C1818F748}"/>
              </a:ext>
            </a:extLst>
          </p:cNvPr>
          <p:cNvSpPr txBox="1"/>
          <p:nvPr/>
        </p:nvSpPr>
        <p:spPr>
          <a:xfrm flipH="1">
            <a:off x="2896079" y="632206"/>
            <a:ext cx="195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  2      3      4 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356ABE2-9AF4-0C67-4AEE-BA197ED92DE0}"/>
              </a:ext>
            </a:extLst>
          </p:cNvPr>
          <p:cNvSpPr txBox="1"/>
          <p:nvPr/>
        </p:nvSpPr>
        <p:spPr>
          <a:xfrm flipH="1">
            <a:off x="8305734" y="940614"/>
            <a:ext cx="195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  2      3      4 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8C93E16-3906-B085-8EB4-642D733EDB41}"/>
              </a:ext>
            </a:extLst>
          </p:cNvPr>
          <p:cNvSpPr txBox="1"/>
          <p:nvPr/>
        </p:nvSpPr>
        <p:spPr>
          <a:xfrm flipH="1">
            <a:off x="3168838" y="4824460"/>
            <a:ext cx="195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  2      3      4 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79DE087-A607-3143-D89A-A73225D89A6F}"/>
              </a:ext>
            </a:extLst>
          </p:cNvPr>
          <p:cNvSpPr txBox="1"/>
          <p:nvPr/>
        </p:nvSpPr>
        <p:spPr>
          <a:xfrm flipH="1">
            <a:off x="9035359" y="2613136"/>
            <a:ext cx="195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  2      3      4  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EC66F8FC-C081-86AF-1CAD-58AD2EE53F60}"/>
              </a:ext>
            </a:extLst>
          </p:cNvPr>
          <p:cNvCxnSpPr>
            <a:cxnSpLocks/>
          </p:cNvCxnSpPr>
          <p:nvPr/>
        </p:nvCxnSpPr>
        <p:spPr>
          <a:xfrm flipH="1">
            <a:off x="4637787" y="1057662"/>
            <a:ext cx="763269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90F6CDD6-3081-7463-D662-CF4898918449}"/>
              </a:ext>
            </a:extLst>
          </p:cNvPr>
          <p:cNvCxnSpPr>
            <a:cxnSpLocks/>
          </p:cNvCxnSpPr>
          <p:nvPr/>
        </p:nvCxnSpPr>
        <p:spPr>
          <a:xfrm flipH="1">
            <a:off x="10211544" y="1519164"/>
            <a:ext cx="946149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0AF4ED6A-3D3B-6DAA-A3D5-3A85D9855EF8}"/>
              </a:ext>
            </a:extLst>
          </p:cNvPr>
          <p:cNvCxnSpPr>
            <a:cxnSpLocks/>
          </p:cNvCxnSpPr>
          <p:nvPr/>
        </p:nvCxnSpPr>
        <p:spPr>
          <a:xfrm flipH="1">
            <a:off x="10756084" y="3014208"/>
            <a:ext cx="946149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682041C4-CA22-7A17-A9C0-1781E7A0A0E4}"/>
              </a:ext>
            </a:extLst>
          </p:cNvPr>
          <p:cNvCxnSpPr>
            <a:cxnSpLocks/>
          </p:cNvCxnSpPr>
          <p:nvPr/>
        </p:nvCxnSpPr>
        <p:spPr>
          <a:xfrm flipH="1">
            <a:off x="4927981" y="5420604"/>
            <a:ext cx="946149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605414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A93088D-1E53-EA00-C7CB-024B0A43D0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1784" y="707136"/>
            <a:ext cx="7772400" cy="263327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A207F13-6E1E-6998-23FB-4652CE1F5CAE}"/>
              </a:ext>
            </a:extLst>
          </p:cNvPr>
          <p:cNvSpPr txBox="1"/>
          <p:nvPr/>
        </p:nvSpPr>
        <p:spPr>
          <a:xfrm>
            <a:off x="341376" y="325612"/>
            <a:ext cx="11576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 3c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AB6DEEC-3626-0403-4B82-9FC48B2113BA}"/>
              </a:ext>
            </a:extLst>
          </p:cNvPr>
          <p:cNvSpPr txBox="1"/>
          <p:nvPr/>
        </p:nvSpPr>
        <p:spPr>
          <a:xfrm>
            <a:off x="10338816" y="1809986"/>
            <a:ext cx="1569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p53(Ser15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1A26E03-9497-D9AE-719F-705FD1331CA5}"/>
              </a:ext>
            </a:extLst>
          </p:cNvPr>
          <p:cNvSpPr txBox="1"/>
          <p:nvPr/>
        </p:nvSpPr>
        <p:spPr>
          <a:xfrm>
            <a:off x="3340608" y="3681984"/>
            <a:ext cx="3057312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ree drug (0.1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ree drug (1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ree drug (5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HES0815A (5 ng/ml)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HES0815A (20 ng/ml)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HES0815A (100 ng/ml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27C9FCC-BC1C-B190-97D7-77368696FD1E}"/>
              </a:ext>
            </a:extLst>
          </p:cNvPr>
          <p:cNvSpPr txBox="1"/>
          <p:nvPr/>
        </p:nvSpPr>
        <p:spPr>
          <a:xfrm>
            <a:off x="6729984" y="3981593"/>
            <a:ext cx="4901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p53 (Ser15) blot was from lane 1, 3, 6 and 7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480B8F66-C71D-9BFC-9DBF-348B55C2F187}"/>
              </a:ext>
            </a:extLst>
          </p:cNvPr>
          <p:cNvCxnSpPr>
            <a:cxnSpLocks/>
          </p:cNvCxnSpPr>
          <p:nvPr/>
        </p:nvCxnSpPr>
        <p:spPr>
          <a:xfrm flipH="1">
            <a:off x="9735312" y="1994652"/>
            <a:ext cx="603504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B798804A-EB83-AB5F-F13E-4F6FAEAC3F0A}"/>
              </a:ext>
            </a:extLst>
          </p:cNvPr>
          <p:cNvCxnSpPr/>
          <p:nvPr/>
        </p:nvCxnSpPr>
        <p:spPr>
          <a:xfrm>
            <a:off x="5401056" y="1164336"/>
            <a:ext cx="0" cy="29260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DF061766-F5B7-A55B-D280-33DFBE2F3E0F}"/>
              </a:ext>
            </a:extLst>
          </p:cNvPr>
          <p:cNvCxnSpPr/>
          <p:nvPr/>
        </p:nvCxnSpPr>
        <p:spPr>
          <a:xfrm>
            <a:off x="6541008" y="1011936"/>
            <a:ext cx="0" cy="29260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15C06A84-E1A9-46D0-A4C0-F3A560ACBFF1}"/>
              </a:ext>
            </a:extLst>
          </p:cNvPr>
          <p:cNvCxnSpPr/>
          <p:nvPr/>
        </p:nvCxnSpPr>
        <p:spPr>
          <a:xfrm>
            <a:off x="4620768" y="1207008"/>
            <a:ext cx="0" cy="29260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35DB2D3E-401E-BDD9-EDD7-B15CB30FD8E1}"/>
              </a:ext>
            </a:extLst>
          </p:cNvPr>
          <p:cNvCxnSpPr/>
          <p:nvPr/>
        </p:nvCxnSpPr>
        <p:spPr>
          <a:xfrm>
            <a:off x="6931152" y="993648"/>
            <a:ext cx="0" cy="29260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865363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05EFD24-221F-F374-59DD-A7044888C2AB}"/>
              </a:ext>
            </a:extLst>
          </p:cNvPr>
          <p:cNvSpPr txBox="1"/>
          <p:nvPr/>
        </p:nvSpPr>
        <p:spPr>
          <a:xfrm>
            <a:off x="487680" y="341376"/>
            <a:ext cx="10887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 3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CF659B7-D157-3ADB-5A33-666A9DBC42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4991" y="341376"/>
            <a:ext cx="7632192" cy="232318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761626E-31AB-061E-9365-09D4F0C2C1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84704" y="3297955"/>
            <a:ext cx="7772400" cy="325524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17B2E47-8439-4947-12E9-59A4B55D048B}"/>
              </a:ext>
            </a:extLst>
          </p:cNvPr>
          <p:cNvSpPr txBox="1"/>
          <p:nvPr/>
        </p:nvSpPr>
        <p:spPr>
          <a:xfrm>
            <a:off x="9912096" y="1400294"/>
            <a:ext cx="1980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H2AX (Ser139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933EB88-2CC7-11FD-4CA3-4AD11CEF0168}"/>
              </a:ext>
            </a:extLst>
          </p:cNvPr>
          <p:cNvSpPr txBox="1"/>
          <p:nvPr/>
        </p:nvSpPr>
        <p:spPr>
          <a:xfrm>
            <a:off x="10561954" y="5786364"/>
            <a:ext cx="1633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p53 (Ser15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E8C3488-9784-B508-A9EF-72F85F107EFF}"/>
              </a:ext>
            </a:extLst>
          </p:cNvPr>
          <p:cNvSpPr txBox="1"/>
          <p:nvPr/>
        </p:nvSpPr>
        <p:spPr>
          <a:xfrm>
            <a:off x="354424" y="4381417"/>
            <a:ext cx="1868845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rastuzumab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-DM1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HES0488A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HES0815A</a:t>
            </a: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54147F31-A2AA-9B7B-88D1-8DD09D3AD46C}"/>
              </a:ext>
            </a:extLst>
          </p:cNvPr>
          <p:cNvCxnSpPr/>
          <p:nvPr/>
        </p:nvCxnSpPr>
        <p:spPr>
          <a:xfrm flipH="1">
            <a:off x="9326880" y="1584960"/>
            <a:ext cx="585216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BD0EA8C9-017B-E4C7-9DD8-DD01E26F3271}"/>
              </a:ext>
            </a:extLst>
          </p:cNvPr>
          <p:cNvCxnSpPr>
            <a:cxnSpLocks/>
          </p:cNvCxnSpPr>
          <p:nvPr/>
        </p:nvCxnSpPr>
        <p:spPr>
          <a:xfrm flipH="1">
            <a:off x="10088880" y="5786364"/>
            <a:ext cx="946149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401756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C3E6DCE-F84D-8F85-7FD0-ED908A2529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2368" y="100702"/>
            <a:ext cx="7772400" cy="202067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94D1E06-323D-9AC9-D212-936761BD7D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82368" y="2194526"/>
            <a:ext cx="7772400" cy="267474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F5145FC-A9DC-C405-D067-51676AC0C09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82368" y="4893657"/>
            <a:ext cx="7772400" cy="199049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F8C1498-F33E-3F04-13BD-5469BBBFEC1C}"/>
              </a:ext>
            </a:extLst>
          </p:cNvPr>
          <p:cNvSpPr txBox="1"/>
          <p:nvPr/>
        </p:nvSpPr>
        <p:spPr>
          <a:xfrm>
            <a:off x="10546080" y="1111037"/>
            <a:ext cx="646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C821170-4BEE-97E2-AC37-D98F5D57E568}"/>
              </a:ext>
            </a:extLst>
          </p:cNvPr>
          <p:cNvSpPr txBox="1"/>
          <p:nvPr/>
        </p:nvSpPr>
        <p:spPr>
          <a:xfrm>
            <a:off x="9777349" y="3299197"/>
            <a:ext cx="2390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Histone H3 (Ser10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87B218E-5475-709C-272C-EDD39E2A4F70}"/>
              </a:ext>
            </a:extLst>
          </p:cNvPr>
          <p:cNvSpPr txBox="1"/>
          <p:nvPr/>
        </p:nvSpPr>
        <p:spPr>
          <a:xfrm>
            <a:off x="10546080" y="5704237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1D82B4D-2891-E02A-6B87-17CCE4C4905D}"/>
              </a:ext>
            </a:extLst>
          </p:cNvPr>
          <p:cNvSpPr txBox="1"/>
          <p:nvPr/>
        </p:nvSpPr>
        <p:spPr>
          <a:xfrm>
            <a:off x="487680" y="341376"/>
            <a:ext cx="10887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 3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3921342-9181-DBF8-CB0B-DFB09B1D2A1C}"/>
              </a:ext>
            </a:extLst>
          </p:cNvPr>
          <p:cNvSpPr txBox="1"/>
          <p:nvPr/>
        </p:nvSpPr>
        <p:spPr>
          <a:xfrm>
            <a:off x="354424" y="4381417"/>
            <a:ext cx="1868845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rastuzumab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-DM1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HES0488A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HES0815A</a:t>
            </a: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5F087D1F-151E-1420-D8A7-755E4BF8D2FD}"/>
              </a:ext>
            </a:extLst>
          </p:cNvPr>
          <p:cNvCxnSpPr>
            <a:cxnSpLocks/>
          </p:cNvCxnSpPr>
          <p:nvPr/>
        </p:nvCxnSpPr>
        <p:spPr>
          <a:xfrm flipH="1">
            <a:off x="9954768" y="1295703"/>
            <a:ext cx="591312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876B9AD7-821F-A66F-2D0D-0A91F30D43EC}"/>
              </a:ext>
            </a:extLst>
          </p:cNvPr>
          <p:cNvCxnSpPr>
            <a:cxnSpLocks/>
          </p:cNvCxnSpPr>
          <p:nvPr/>
        </p:nvCxnSpPr>
        <p:spPr>
          <a:xfrm flipH="1">
            <a:off x="9777349" y="3226044"/>
            <a:ext cx="946149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D1F1CCF2-C777-4E52-9A2D-1EB9E7A6AEAD}"/>
              </a:ext>
            </a:extLst>
          </p:cNvPr>
          <p:cNvCxnSpPr>
            <a:cxnSpLocks/>
          </p:cNvCxnSpPr>
          <p:nvPr/>
        </p:nvCxnSpPr>
        <p:spPr>
          <a:xfrm flipH="1">
            <a:off x="9599931" y="5888903"/>
            <a:ext cx="946149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845555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152</Words>
  <Application>Microsoft Macintosh PowerPoint</Application>
  <PresentationFormat>Widescreen</PresentationFormat>
  <Paragraphs>5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Gail Lewis</cp:lastModifiedBy>
  <cp:revision>27</cp:revision>
  <dcterms:created xsi:type="dcterms:W3CDTF">2023-08-04T22:12:17Z</dcterms:created>
  <dcterms:modified xsi:type="dcterms:W3CDTF">2023-08-09T22:45:23Z</dcterms:modified>
</cp:coreProperties>
</file>